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8285" autoAdjust="0"/>
  </p:normalViewPr>
  <p:slideViewPr>
    <p:cSldViewPr snapToGrid="0" snapToObjects="1">
      <p:cViewPr>
        <p:scale>
          <a:sx n="100" d="100"/>
          <a:sy n="100" d="100"/>
        </p:scale>
        <p:origin x="-930" y="-2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615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896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291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16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195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9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303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759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902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292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81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678AB-80E0-2E41-8A49-E195B7B2D913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A13D5-86FA-9F4C-AD57-5E8F8DD24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25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34"/>
          <p:cNvSpPr/>
          <p:nvPr/>
        </p:nvSpPr>
        <p:spPr>
          <a:xfrm rot="18008521">
            <a:off x="519325" y="644224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1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 rot="18008521">
            <a:off x="824574" y="644224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 rot="18008521">
            <a:off x="1095823" y="644224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 rot="18008521">
            <a:off x="1396735" y="644224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4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 rot="18008521">
            <a:off x="1688009" y="644224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5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0" name="Rectangle 39"/>
          <p:cNvSpPr/>
          <p:nvPr/>
        </p:nvSpPr>
        <p:spPr>
          <a:xfrm rot="18008521">
            <a:off x="2011812" y="718886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 rot="18008521">
            <a:off x="2305024" y="718886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 rot="18008521">
            <a:off x="390499" y="907330"/>
            <a:ext cx="325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WT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692281" y="1404914"/>
            <a:ext cx="4817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dirty="0" smtClean="0"/>
              <a:t>ubulin</a:t>
            </a:r>
            <a:endParaRPr lang="en-US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2692281" y="1188286"/>
            <a:ext cx="5246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RHOXF2</a:t>
            </a:r>
            <a:endParaRPr lang="en-US" sz="800" dirty="0"/>
          </a:p>
        </p:txBody>
      </p:sp>
      <p:sp>
        <p:nvSpPr>
          <p:cNvPr id="46" name="Rectangle 45"/>
          <p:cNvSpPr/>
          <p:nvPr/>
        </p:nvSpPr>
        <p:spPr>
          <a:xfrm>
            <a:off x="417290" y="1647317"/>
            <a:ext cx="22609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K562 + 35μM </a:t>
            </a:r>
            <a:r>
              <a:rPr lang="en-US" dirty="0" err="1" smtClean="0">
                <a:solidFill>
                  <a:srgbClr val="000000"/>
                </a:solidFill>
              </a:rPr>
              <a:t>cisplatin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48" name="Rectangle 47"/>
          <p:cNvSpPr/>
          <p:nvPr/>
        </p:nvSpPr>
        <p:spPr>
          <a:xfrm rot="18008521">
            <a:off x="539011" y="2601413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1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9" name="Rectangle 48"/>
          <p:cNvSpPr/>
          <p:nvPr/>
        </p:nvSpPr>
        <p:spPr>
          <a:xfrm rot="18008521">
            <a:off x="823093" y="2601413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 rot="18008521">
            <a:off x="1119743" y="2601413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1" name="Rectangle 50"/>
          <p:cNvSpPr/>
          <p:nvPr/>
        </p:nvSpPr>
        <p:spPr>
          <a:xfrm rot="18008521">
            <a:off x="1416420" y="2601413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4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2" name="Rectangle 51"/>
          <p:cNvSpPr/>
          <p:nvPr/>
        </p:nvSpPr>
        <p:spPr>
          <a:xfrm rot="18008521">
            <a:off x="1711929" y="2601413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5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 rot="18008521">
            <a:off x="2048432" y="2676075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 rot="18008521">
            <a:off x="2303544" y="2676075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 rot="18008521">
            <a:off x="389017" y="2864519"/>
            <a:ext cx="325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WT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692281" y="3355558"/>
            <a:ext cx="4817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dirty="0" smtClean="0"/>
              <a:t>ubulin</a:t>
            </a:r>
            <a:endParaRPr lang="en-US" sz="800" dirty="0"/>
          </a:p>
        </p:txBody>
      </p:sp>
      <p:sp>
        <p:nvSpPr>
          <p:cNvPr id="57" name="TextBox 56"/>
          <p:cNvSpPr txBox="1"/>
          <p:nvPr/>
        </p:nvSpPr>
        <p:spPr>
          <a:xfrm>
            <a:off x="2692281" y="3149622"/>
            <a:ext cx="5246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RHOXF2</a:t>
            </a:r>
            <a:endParaRPr lang="en-US" sz="800" dirty="0"/>
          </a:p>
        </p:txBody>
      </p:sp>
      <p:sp>
        <p:nvSpPr>
          <p:cNvPr id="58" name="Rectangle 57"/>
          <p:cNvSpPr/>
          <p:nvPr/>
        </p:nvSpPr>
        <p:spPr>
          <a:xfrm>
            <a:off x="299528" y="3591806"/>
            <a:ext cx="25442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K562 + 7μM </a:t>
            </a:r>
            <a:r>
              <a:rPr lang="en-US" dirty="0" err="1" smtClean="0">
                <a:solidFill>
                  <a:srgbClr val="000000"/>
                </a:solidFill>
              </a:rPr>
              <a:t>mitomycin</a:t>
            </a:r>
            <a:r>
              <a:rPr lang="en-US" dirty="0" smtClean="0">
                <a:solidFill>
                  <a:srgbClr val="000000"/>
                </a:solidFill>
              </a:rPr>
              <a:t> C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879" y="3398934"/>
            <a:ext cx="2340942" cy="172718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879" y="3165239"/>
            <a:ext cx="2340942" cy="172718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879" y="1440248"/>
            <a:ext cx="2340942" cy="188982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5879" y="1214748"/>
            <a:ext cx="2340942" cy="188982"/>
          </a:xfrm>
          <a:prstGeom prst="rect">
            <a:avLst/>
          </a:prstGeom>
        </p:spPr>
      </p:pic>
      <p:sp>
        <p:nvSpPr>
          <p:cNvPr id="66" name="TextBox 65"/>
          <p:cNvSpPr txBox="1"/>
          <p:nvPr/>
        </p:nvSpPr>
        <p:spPr>
          <a:xfrm>
            <a:off x="296121" y="22258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73926" y="2400331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4" name="Rectangle 11"/>
          <p:cNvSpPr>
            <a:spLocks noChangeArrowheads="1"/>
          </p:cNvSpPr>
          <p:nvPr/>
        </p:nvSpPr>
        <p:spPr bwMode="auto">
          <a:xfrm>
            <a:off x="7490791" y="6465598"/>
            <a:ext cx="168507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File </a:t>
            </a:r>
            <a:r>
              <a:rPr lang="en-US" sz="1600" b="1" dirty="0" smtClean="0">
                <a:sym typeface="Monotype Sorts" pitchFamily="-112" charset="2"/>
              </a:rPr>
              <a:t>13</a:t>
            </a:r>
            <a:endParaRPr lang="en-US" sz="1600" b="1" dirty="0">
              <a:sym typeface="Monotype Sorts" pitchFamily="-11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49996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</TotalTime>
  <Words>34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 of Toron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50</cp:revision>
  <dcterms:created xsi:type="dcterms:W3CDTF">2011-10-18T21:01:57Z</dcterms:created>
  <dcterms:modified xsi:type="dcterms:W3CDTF">2014-05-20T08:14:49Z</dcterms:modified>
</cp:coreProperties>
</file>